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8FAC5A-DAF1-4863-A1CD-77C4987DF2AD}" v="15" dt="2024-11-07T16:29:38.2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>
        <p:scale>
          <a:sx n="118" d="100"/>
          <a:sy n="118" d="100"/>
        </p:scale>
        <p:origin x="-312" y="19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e Pintus" userId="59ea9326d64967c7" providerId="LiveId" clId="{1C8FAC5A-DAF1-4863-A1CD-77C4987DF2AD}"/>
    <pc:docChg chg="custSel addSld delSld modSld sldOrd">
      <pc:chgData name="Davide Pintus" userId="59ea9326d64967c7" providerId="LiveId" clId="{1C8FAC5A-DAF1-4863-A1CD-77C4987DF2AD}" dt="2024-11-07T16:32:25.340" v="437" actId="14100"/>
      <pc:docMkLst>
        <pc:docMk/>
      </pc:docMkLst>
      <pc:sldChg chg="modSp del mod">
        <pc:chgData name="Davide Pintus" userId="59ea9326d64967c7" providerId="LiveId" clId="{1C8FAC5A-DAF1-4863-A1CD-77C4987DF2AD}" dt="2024-11-07T16:26:33.901" v="344" actId="47"/>
        <pc:sldMkLst>
          <pc:docMk/>
          <pc:sldMk cId="292884898" sldId="256"/>
        </pc:sldMkLst>
        <pc:spChg chg="mod">
          <ac:chgData name="Davide Pintus" userId="59ea9326d64967c7" providerId="LiveId" clId="{1C8FAC5A-DAF1-4863-A1CD-77C4987DF2AD}" dt="2024-11-05T14:16:56.004" v="0" actId="20577"/>
          <ac:spMkLst>
            <pc:docMk/>
            <pc:sldMk cId="292884898" sldId="256"/>
            <ac:spMk id="6" creationId="{3292C645-C876-7851-E41F-790C6C244777}"/>
          </ac:spMkLst>
        </pc:spChg>
      </pc:sldChg>
      <pc:sldChg chg="addSp delSp modSp del mod ord modAnim">
        <pc:chgData name="Davide Pintus" userId="59ea9326d64967c7" providerId="LiveId" clId="{1C8FAC5A-DAF1-4863-A1CD-77C4987DF2AD}" dt="2024-11-07T16:26:35.144" v="345" actId="47"/>
        <pc:sldMkLst>
          <pc:docMk/>
          <pc:sldMk cId="95780648" sldId="258"/>
        </pc:sldMkLst>
        <pc:spChg chg="add mod">
          <ac:chgData name="Davide Pintus" userId="59ea9326d64967c7" providerId="LiveId" clId="{1C8FAC5A-DAF1-4863-A1CD-77C4987DF2AD}" dt="2024-11-07T15:55:06.029" v="15" actId="1076"/>
          <ac:spMkLst>
            <pc:docMk/>
            <pc:sldMk cId="95780648" sldId="258"/>
            <ac:spMk id="2" creationId="{5CE4106D-2102-AA63-F8C3-BB565E046124}"/>
          </ac:spMkLst>
        </pc:spChg>
        <pc:spChg chg="del">
          <ac:chgData name="Davide Pintus" userId="59ea9326d64967c7" providerId="LiveId" clId="{1C8FAC5A-DAF1-4863-A1CD-77C4987DF2AD}" dt="2024-11-07T15:54:41.351" v="9" actId="478"/>
          <ac:spMkLst>
            <pc:docMk/>
            <pc:sldMk cId="95780648" sldId="258"/>
            <ac:spMk id="25" creationId="{D45396F7-CA02-2568-F359-2661E6B8F283}"/>
          </ac:spMkLst>
        </pc:spChg>
        <pc:spChg chg="del topLvl">
          <ac:chgData name="Davide Pintus" userId="59ea9326d64967c7" providerId="LiveId" clId="{1C8FAC5A-DAF1-4863-A1CD-77C4987DF2AD}" dt="2024-11-07T15:55:14.265" v="16" actId="478"/>
          <ac:spMkLst>
            <pc:docMk/>
            <pc:sldMk cId="95780648" sldId="258"/>
            <ac:spMk id="26" creationId="{7638CDA7-EEBD-F90C-2AA3-4AB0EEECE35C}"/>
          </ac:spMkLst>
        </pc:spChg>
        <pc:grpChg chg="topLvl">
          <ac:chgData name="Davide Pintus" userId="59ea9326d64967c7" providerId="LiveId" clId="{1C8FAC5A-DAF1-4863-A1CD-77C4987DF2AD}" dt="2024-11-07T15:55:14.265" v="16" actId="478"/>
          <ac:grpSpMkLst>
            <pc:docMk/>
            <pc:sldMk cId="95780648" sldId="258"/>
            <ac:grpSpMk id="23" creationId="{DB964151-31B9-9FA4-AD9A-AFFEA4BA29B0}"/>
          </ac:grpSpMkLst>
        </pc:grpChg>
        <pc:grpChg chg="del">
          <ac:chgData name="Davide Pintus" userId="59ea9326d64967c7" providerId="LiveId" clId="{1C8FAC5A-DAF1-4863-A1CD-77C4987DF2AD}" dt="2024-11-07T15:55:14.265" v="16" actId="478"/>
          <ac:grpSpMkLst>
            <pc:docMk/>
            <pc:sldMk cId="95780648" sldId="258"/>
            <ac:grpSpMk id="27" creationId="{375E5EFF-564B-58E3-941F-6D319D383401}"/>
          </ac:grpSpMkLst>
        </pc:grpChg>
        <pc:picChg chg="add mod modCrop">
          <ac:chgData name="Davide Pintus" userId="59ea9326d64967c7" providerId="LiveId" clId="{1C8FAC5A-DAF1-4863-A1CD-77C4987DF2AD}" dt="2024-11-07T16:14:39.603" v="70" actId="1076"/>
          <ac:picMkLst>
            <pc:docMk/>
            <pc:sldMk cId="95780648" sldId="258"/>
            <ac:picMk id="3" creationId="{18353D1F-D65D-B745-264B-B87D8C5385D5}"/>
          </ac:picMkLst>
        </pc:picChg>
      </pc:sldChg>
      <pc:sldChg chg="addSp delSp modSp new del mod">
        <pc:chgData name="Davide Pintus" userId="59ea9326d64967c7" providerId="LiveId" clId="{1C8FAC5A-DAF1-4863-A1CD-77C4987DF2AD}" dt="2024-11-07T16:26:32.978" v="343" actId="47"/>
        <pc:sldMkLst>
          <pc:docMk/>
          <pc:sldMk cId="2665006698" sldId="259"/>
        </pc:sldMkLst>
        <pc:spChg chg="del">
          <ac:chgData name="Davide Pintus" userId="59ea9326d64967c7" providerId="LiveId" clId="{1C8FAC5A-DAF1-4863-A1CD-77C4987DF2AD}" dt="2024-11-07T15:53:42.702" v="3" actId="478"/>
          <ac:spMkLst>
            <pc:docMk/>
            <pc:sldMk cId="2665006698" sldId="259"/>
            <ac:spMk id="2" creationId="{C4F069FE-3995-62EA-7192-C6F3FAF84E31}"/>
          </ac:spMkLst>
        </pc:spChg>
        <pc:spChg chg="del">
          <ac:chgData name="Davide Pintus" userId="59ea9326d64967c7" providerId="LiveId" clId="{1C8FAC5A-DAF1-4863-A1CD-77C4987DF2AD}" dt="2024-11-07T15:53:41.943" v="2" actId="478"/>
          <ac:spMkLst>
            <pc:docMk/>
            <pc:sldMk cId="2665006698" sldId="259"/>
            <ac:spMk id="3" creationId="{27B143EB-3455-7035-0E77-F57BADB75DEC}"/>
          </ac:spMkLst>
        </pc:spChg>
        <pc:spChg chg="add del mod">
          <ac:chgData name="Davide Pintus" userId="59ea9326d64967c7" providerId="LiveId" clId="{1C8FAC5A-DAF1-4863-A1CD-77C4987DF2AD}" dt="2024-11-07T16:24:28.488" v="310" actId="21"/>
          <ac:spMkLst>
            <pc:docMk/>
            <pc:sldMk cId="2665006698" sldId="259"/>
            <ac:spMk id="5" creationId="{E33E4272-66B9-1592-AF21-C431E90D4DCD}"/>
          </ac:spMkLst>
        </pc:spChg>
        <pc:spChg chg="add mod">
          <ac:chgData name="Davide Pintus" userId="59ea9326d64967c7" providerId="LiveId" clId="{1C8FAC5A-DAF1-4863-A1CD-77C4987DF2AD}" dt="2024-11-07T16:05:30.986" v="46" actId="14100"/>
          <ac:spMkLst>
            <pc:docMk/>
            <pc:sldMk cId="2665006698" sldId="259"/>
            <ac:spMk id="7" creationId="{ACA5A8C7-BEE9-9A92-1A4A-41DD6B239853}"/>
          </ac:spMkLst>
        </pc:spChg>
        <pc:spChg chg="add mod">
          <ac:chgData name="Davide Pintus" userId="59ea9326d64967c7" providerId="LiveId" clId="{1C8FAC5A-DAF1-4863-A1CD-77C4987DF2AD}" dt="2024-11-07T16:05:34.771" v="47" actId="1076"/>
          <ac:spMkLst>
            <pc:docMk/>
            <pc:sldMk cId="2665006698" sldId="259"/>
            <ac:spMk id="9" creationId="{B1D4A592-61C1-8696-5E6A-F5578C8B993F}"/>
          </ac:spMkLst>
        </pc:spChg>
      </pc:sldChg>
      <pc:sldChg chg="addSp delSp modSp add mod delAnim modAnim">
        <pc:chgData name="Davide Pintus" userId="59ea9326d64967c7" providerId="LiveId" clId="{1C8FAC5A-DAF1-4863-A1CD-77C4987DF2AD}" dt="2024-11-07T16:32:25.340" v="437" actId="14100"/>
        <pc:sldMkLst>
          <pc:docMk/>
          <pc:sldMk cId="2371665704" sldId="260"/>
        </pc:sldMkLst>
        <pc:spChg chg="mod ord">
          <ac:chgData name="Davide Pintus" userId="59ea9326d64967c7" providerId="LiveId" clId="{1C8FAC5A-DAF1-4863-A1CD-77C4987DF2AD}" dt="2024-11-07T16:26:11.510" v="341" actId="1076"/>
          <ac:spMkLst>
            <pc:docMk/>
            <pc:sldMk cId="2371665704" sldId="260"/>
            <ac:spMk id="2" creationId="{1E7675FE-D106-CA10-0CED-A6CFD20C801B}"/>
          </ac:spMkLst>
        </pc:spChg>
        <pc:spChg chg="add mod">
          <ac:chgData name="Davide Pintus" userId="59ea9326d64967c7" providerId="LiveId" clId="{1C8FAC5A-DAF1-4863-A1CD-77C4987DF2AD}" dt="2024-11-07T16:30:00.074" v="421" actId="1076"/>
          <ac:spMkLst>
            <pc:docMk/>
            <pc:sldMk cId="2371665704" sldId="260"/>
            <ac:spMk id="6" creationId="{E33E4272-66B9-1592-AF21-C431E90D4DCD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8" creationId="{12229C0B-2B52-F5D1-FBC9-13CA0D0B4673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11" creationId="{AA18A6FF-240A-9922-ABD9-8812811C20D1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17" creationId="{F1A95655-4FC3-BF71-E4B4-5EECEEFB1876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18" creationId="{7477E39C-0B50-87FE-5F3F-0BC8E2FF2915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20" creationId="{2F91A4C9-4A71-582D-817A-7A4B5FDAF026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21" creationId="{BF8D6521-077A-B8E2-4CD6-8A25DD1D7EBA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22" creationId="{DF6AEEBE-628A-9BBD-DC7F-8F84076189B9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24" creationId="{3A4EF224-E652-035C-523E-D2884B4A5648}"/>
          </ac:spMkLst>
        </pc:spChg>
        <pc:spChg chg="add mod">
          <ac:chgData name="Davide Pintus" userId="59ea9326d64967c7" providerId="LiveId" clId="{1C8FAC5A-DAF1-4863-A1CD-77C4987DF2AD}" dt="2024-11-07T16:29:38.283" v="394" actId="164"/>
          <ac:spMkLst>
            <pc:docMk/>
            <pc:sldMk cId="2371665704" sldId="260"/>
            <ac:spMk id="25" creationId="{032EE70F-3545-19C4-D897-7249D29B1364}"/>
          </ac:spMkLst>
        </pc:spChg>
        <pc:grpChg chg="add mod">
          <ac:chgData name="Davide Pintus" userId="59ea9326d64967c7" providerId="LiveId" clId="{1C8FAC5A-DAF1-4863-A1CD-77C4987DF2AD}" dt="2024-11-07T16:29:38.283" v="394" actId="164"/>
          <ac:grpSpMkLst>
            <pc:docMk/>
            <pc:sldMk cId="2371665704" sldId="260"/>
            <ac:grpSpMk id="7" creationId="{E1B88884-FCAB-37F6-2199-4D59E8FC288C}"/>
          </ac:grpSpMkLst>
        </pc:grpChg>
        <pc:grpChg chg="mod">
          <ac:chgData name="Davide Pintus" userId="59ea9326d64967c7" providerId="LiveId" clId="{1C8FAC5A-DAF1-4863-A1CD-77C4987DF2AD}" dt="2024-11-07T16:24:57.501" v="318" actId="164"/>
          <ac:grpSpMkLst>
            <pc:docMk/>
            <pc:sldMk cId="2371665704" sldId="260"/>
            <ac:grpSpMk id="23" creationId="{02E940E5-407A-88E3-2D34-F6047D43BADE}"/>
          </ac:grpSpMkLst>
        </pc:grpChg>
        <pc:grpChg chg="add mod">
          <ac:chgData name="Davide Pintus" userId="59ea9326d64967c7" providerId="LiveId" clId="{1C8FAC5A-DAF1-4863-A1CD-77C4987DF2AD}" dt="2024-11-07T16:29:49.787" v="418" actId="1036"/>
          <ac:grpSpMkLst>
            <pc:docMk/>
            <pc:sldMk cId="2371665704" sldId="260"/>
            <ac:grpSpMk id="26" creationId="{AC92AE18-0155-C822-71B4-DFC0EE1899B6}"/>
          </ac:grpSpMkLst>
        </pc:grpChg>
        <pc:picChg chg="del mod">
          <ac:chgData name="Davide Pintus" userId="59ea9326d64967c7" providerId="LiveId" clId="{1C8FAC5A-DAF1-4863-A1CD-77C4987DF2AD}" dt="2024-11-07T16:16:31.887" v="73" actId="478"/>
          <ac:picMkLst>
            <pc:docMk/>
            <pc:sldMk cId="2371665704" sldId="260"/>
            <ac:picMk id="3" creationId="{DA86A412-126A-E9CB-A8BE-34CB765CF7FB}"/>
          </ac:picMkLst>
        </pc:picChg>
        <pc:picChg chg="add mod modCrop">
          <ac:chgData name="Davide Pintus" userId="59ea9326d64967c7" providerId="LiveId" clId="{1C8FAC5A-DAF1-4863-A1CD-77C4987DF2AD}" dt="2024-11-07T16:24:57.501" v="318" actId="164"/>
          <ac:picMkLst>
            <pc:docMk/>
            <pc:sldMk cId="2371665704" sldId="260"/>
            <ac:picMk id="4" creationId="{2C8A8759-6BCB-3FA5-88D1-EF79E44A1645}"/>
          </ac:picMkLst>
        </pc:picChg>
        <pc:picChg chg="del">
          <ac:chgData name="Davide Pintus" userId="59ea9326d64967c7" providerId="LiveId" clId="{1C8FAC5A-DAF1-4863-A1CD-77C4987DF2AD}" dt="2024-11-07T16:00:49.563" v="31" actId="478"/>
          <ac:picMkLst>
            <pc:docMk/>
            <pc:sldMk cId="2371665704" sldId="260"/>
            <ac:picMk id="10" creationId="{A7A49CE7-370B-9E4F-8B97-A503EC9A3946}"/>
          </ac:picMkLst>
        </pc:picChg>
        <pc:picChg chg="mod modCrop">
          <ac:chgData name="Davide Pintus" userId="59ea9326d64967c7" providerId="LiveId" clId="{1C8FAC5A-DAF1-4863-A1CD-77C4987DF2AD}" dt="2024-11-07T16:30:50.033" v="422" actId="732"/>
          <ac:picMkLst>
            <pc:docMk/>
            <pc:sldMk cId="2371665704" sldId="260"/>
            <ac:picMk id="12" creationId="{8B8B6526-E1B1-462C-BC8B-F28486692193}"/>
          </ac:picMkLst>
        </pc:picChg>
        <pc:picChg chg="mod modCrop">
          <ac:chgData name="Davide Pintus" userId="59ea9326d64967c7" providerId="LiveId" clId="{1C8FAC5A-DAF1-4863-A1CD-77C4987DF2AD}" dt="2024-11-07T16:32:25.340" v="437" actId="14100"/>
          <ac:picMkLst>
            <pc:docMk/>
            <pc:sldMk cId="2371665704" sldId="260"/>
            <ac:picMk id="14" creationId="{0584832E-23EB-1319-A0D9-421C7859EB42}"/>
          </ac:picMkLst>
        </pc:picChg>
        <pc:picChg chg="mod modCrop">
          <ac:chgData name="Davide Pintus" userId="59ea9326d64967c7" providerId="LiveId" clId="{1C8FAC5A-DAF1-4863-A1CD-77C4987DF2AD}" dt="2024-11-07T16:31:37.518" v="430" actId="1036"/>
          <ac:picMkLst>
            <pc:docMk/>
            <pc:sldMk cId="2371665704" sldId="260"/>
            <ac:picMk id="15" creationId="{3393CB0A-00FD-19D0-8CCF-C75F699A0FCC}"/>
          </ac:picMkLst>
        </pc:picChg>
        <pc:picChg chg="mod">
          <ac:chgData name="Davide Pintus" userId="59ea9326d64967c7" providerId="LiveId" clId="{1C8FAC5A-DAF1-4863-A1CD-77C4987DF2AD}" dt="2024-11-07T16:01:23.074" v="37" actId="1076"/>
          <ac:picMkLst>
            <pc:docMk/>
            <pc:sldMk cId="2371665704" sldId="260"/>
            <ac:picMk id="16" creationId="{468E3EA2-E3AF-271D-B4E3-749F2242239B}"/>
          </ac:picMkLst>
        </pc:picChg>
        <pc:picChg chg="mod modCrop">
          <ac:chgData name="Davide Pintus" userId="59ea9326d64967c7" providerId="LiveId" clId="{1C8FAC5A-DAF1-4863-A1CD-77C4987DF2AD}" dt="2024-11-07T16:31:55.892" v="433" actId="14100"/>
          <ac:picMkLst>
            <pc:docMk/>
            <pc:sldMk cId="2371665704" sldId="260"/>
            <ac:picMk id="19" creationId="{6BE8DB79-C11A-1E64-6012-4B3D486D4FB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3F4BF8FD-8513-0316-FB54-586D283020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xmlns="" id="{10AF34C5-C837-AAFD-F821-1E9C841C50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8815A830-54AE-36DD-CE1B-A78B742B9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A2BC1EFD-C239-057D-F73A-E842C12D9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C4CCA956-D01A-50B1-AA82-63E3EC5A9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014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67267BA3-43D1-5862-F353-362A064AD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54D476BE-7F6B-DE42-2B07-41AB59E026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E78A1809-E6DF-FAA2-ECC0-8AAD5EB1A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31CB0FF2-AD40-942A-BD06-0521C888E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5A19A02E-5321-39AF-D26D-2AA9A51B3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583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xmlns="" id="{AF0C397F-7A46-EE28-7732-72E5339C8F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675F2C1A-D50B-55C5-CFEB-34694DCEF4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A793C9B3-E359-DC4A-E2F1-4933D1B36A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AEF1299C-B67A-DEFA-70A1-C62079BDE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A2D1C16D-7868-77A9-C109-A234066D0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4116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A0E7EB05-ED32-0787-9E51-524E2C1A7C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2D9217EC-CC32-DC2A-1E6C-9D69E07E4A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26B19129-9EBE-3C07-B3E1-5532ECD45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ED756922-C06D-2A9B-A001-A70463057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60296657-1A44-FFFE-0A18-A3B92E853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73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8A7DE3AE-ED26-2605-5923-14A1A23DE0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071E8C9A-C009-0066-A01A-F8F23E4581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81D4B31F-5050-10E3-8F12-671E8DCFA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04DBE77E-36EC-DFAA-5EDE-E51D021D3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FB4C737F-60A9-7FD0-1A44-D78B0A8B3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5431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C4CEB596-A951-26EC-0B4A-DF48B8594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DFEC7272-46D3-9325-3134-A07E4F50CA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1CECE6BA-92EF-5561-7C30-14CFED641D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93BA0B7B-99C8-2F7D-7D94-3370E331A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12FF08C9-682E-248D-6D40-C611F9576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51E14E76-164E-D34D-3477-96D8F9B3C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2747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97C8F347-9580-A849-08D6-395BC0BE65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0259B2DC-8DD8-B910-1B7F-8362AE506B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AB7ACDCE-AC9A-102B-792E-0DF45E550B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xmlns="" id="{3268AE7D-7393-CB03-263A-0CB40C5FC8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xmlns="" id="{6A209C40-2E4E-1495-921D-E8A6ED84B9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xmlns="" id="{6552F1F2-0BDF-0027-F5C5-423A09EC6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xmlns="" id="{8BFF7F59-DE90-4C01-381E-9682AFA85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xmlns="" id="{3F3B493E-F4F8-7ECB-C286-526673A1C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306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8578F942-C50B-ED01-FA80-293E49A9C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xmlns="" id="{92CC2BAB-BF39-8056-199A-0F9EE44FD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xmlns="" id="{B057B932-C4A4-0B39-25FF-075A1ADE3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xmlns="" id="{2D6354A2-8E04-0E2A-04E3-2730FD771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9466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xmlns="" id="{440B5E40-02E2-D8D8-A070-9A2F007F4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xmlns="" id="{0023E02E-BB02-6F50-0962-2C961E3F4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xmlns="" id="{0933D733-65D2-1363-BB94-79746C054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0925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BFF5A9E6-A761-872E-050B-CCE5BBCEE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BD081E64-7208-ADD6-5C8F-F118977D91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690D0E64-DC8B-25FA-69CA-D927332373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91BFDEFE-B5E3-6709-62C9-9BB31A518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570B4B57-BF4D-FDBF-C7CE-E07CF5867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4D2D8789-588B-0C2C-371A-B2E23B021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0331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B04A1648-616C-D368-DD4C-A4E51AA0FF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xmlns="" id="{12AEA003-74F7-DA1E-D42F-216D187BFF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D1068C59-DC67-7794-C0C0-ECF335C955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29830426-4924-5CCD-FD10-47D1E6FD6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77ABC8FC-9A77-7B69-75BD-BE5C20A6F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F9010528-177A-DD5E-FDE5-A6707F002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5483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xmlns="" id="{2A443BEA-8B1E-6A22-40A3-33725F562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2EF4564B-160B-0AE3-10FF-2BBA404B0F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5811E2CC-27E9-CB83-5DBF-DD8792A06A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047F6A-D587-4925-B13A-E92BA545278C}" type="datetimeFigureOut">
              <a:rPr lang="it-IT" smtClean="0"/>
              <a:t>14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4A88D63D-2DA9-5791-F6BE-14ED97BC1A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F47B5BE8-2C8D-3692-8F91-D8D18D60C0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A4487F-21D7-46CA-BE0B-2E8EE89870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7797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CC1FFBF3-A85F-39E8-BB12-B1921743E4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uppo 25">
            <a:extLst>
              <a:ext uri="{FF2B5EF4-FFF2-40B4-BE49-F238E27FC236}">
                <a16:creationId xmlns:a16="http://schemas.microsoft.com/office/drawing/2014/main" xmlns="" id="{AC92AE18-0155-C822-71B4-DFC0EE1899B6}"/>
              </a:ext>
            </a:extLst>
          </p:cNvPr>
          <p:cNvGrpSpPr/>
          <p:nvPr/>
        </p:nvGrpSpPr>
        <p:grpSpPr>
          <a:xfrm>
            <a:off x="2137585" y="292100"/>
            <a:ext cx="8110730" cy="5542964"/>
            <a:chOff x="2137585" y="-12700"/>
            <a:chExt cx="8110730" cy="5542964"/>
          </a:xfrm>
        </p:grpSpPr>
        <p:grpSp>
          <p:nvGrpSpPr>
            <p:cNvPr id="7" name="Gruppo 6">
              <a:extLst>
                <a:ext uri="{FF2B5EF4-FFF2-40B4-BE49-F238E27FC236}">
                  <a16:creationId xmlns:a16="http://schemas.microsoft.com/office/drawing/2014/main" xmlns="" id="{E1B88884-FCAB-37F6-2199-4D59E8FC288C}"/>
                </a:ext>
              </a:extLst>
            </p:cNvPr>
            <p:cNvGrpSpPr/>
            <p:nvPr/>
          </p:nvGrpSpPr>
          <p:grpSpPr>
            <a:xfrm>
              <a:off x="2199327" y="39715"/>
              <a:ext cx="8048988" cy="5490549"/>
              <a:chOff x="2262827" y="666084"/>
              <a:chExt cx="8048988" cy="5490549"/>
            </a:xfrm>
          </p:grpSpPr>
          <p:grpSp>
            <p:nvGrpSpPr>
              <p:cNvPr id="23" name="Gruppo 22">
                <a:extLst>
                  <a:ext uri="{FF2B5EF4-FFF2-40B4-BE49-F238E27FC236}">
                    <a16:creationId xmlns:a16="http://schemas.microsoft.com/office/drawing/2014/main" xmlns="" id="{02E940E5-407A-88E3-2D34-F6047D43BADE}"/>
                  </a:ext>
                </a:extLst>
              </p:cNvPr>
              <p:cNvGrpSpPr/>
              <p:nvPr/>
            </p:nvGrpSpPr>
            <p:grpSpPr>
              <a:xfrm>
                <a:off x="2262827" y="666084"/>
                <a:ext cx="8048987" cy="5490549"/>
                <a:chOff x="1978013" y="579210"/>
                <a:chExt cx="8048987" cy="5490549"/>
              </a:xfrm>
            </p:grpSpPr>
            <p:pic>
              <p:nvPicPr>
                <p:cNvPr id="5" name="Immagine 4" descr="Immagine che contiene Carne, Grasso animale, carne, sangue&#10;&#10;Descrizione generata automaticamente">
                  <a:extLst>
                    <a:ext uri="{FF2B5EF4-FFF2-40B4-BE49-F238E27FC236}">
                      <a16:creationId xmlns:a16="http://schemas.microsoft.com/office/drawing/2014/main" xmlns="" id="{CC03D596-B85C-B100-8203-A473A15D9A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640" t="8088" r="26967" b="15191"/>
                <a:stretch/>
              </p:blipFill>
              <p:spPr>
                <a:xfrm>
                  <a:off x="5208587" y="4241350"/>
                  <a:ext cx="2236903" cy="1828408"/>
                </a:xfrm>
                <a:prstGeom prst="rect">
                  <a:avLst/>
                </a:prstGeom>
              </p:spPr>
            </p:pic>
            <p:pic>
              <p:nvPicPr>
                <p:cNvPr id="9" name="Immagine 8" descr="Immagine che contiene cibo, Fast food, carne, interno&#10;&#10;Descrizione generata automaticamente">
                  <a:extLst>
                    <a:ext uri="{FF2B5EF4-FFF2-40B4-BE49-F238E27FC236}">
                      <a16:creationId xmlns:a16="http://schemas.microsoft.com/office/drawing/2014/main" xmlns="" id="{963291C9-01CE-3366-976A-081CDE9EB4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564" r="-833" b="15191"/>
                <a:stretch/>
              </p:blipFill>
              <p:spPr>
                <a:xfrm>
                  <a:off x="1978016" y="4241351"/>
                  <a:ext cx="3199984" cy="1828408"/>
                </a:xfrm>
                <a:prstGeom prst="rect">
                  <a:avLst/>
                </a:prstGeom>
              </p:spPr>
            </p:pic>
            <p:pic>
              <p:nvPicPr>
                <p:cNvPr id="12" name="Immagine 11" descr="DSC09569.JPG">
                  <a:extLst>
                    <a:ext uri="{FF2B5EF4-FFF2-40B4-BE49-F238E27FC236}">
                      <a16:creationId xmlns:a16="http://schemas.microsoft.com/office/drawing/2014/main" xmlns="" id="{8B8B6526-E1B1-462C-BC8B-F2848669219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/>
                <a:srcRect l="7476" t="2781" r="4326" b="3801"/>
                <a:stretch/>
              </p:blipFill>
              <p:spPr>
                <a:xfrm>
                  <a:off x="1978014" y="591911"/>
                  <a:ext cx="2848819" cy="1697299"/>
                </a:xfrm>
                <a:prstGeom prst="rect">
                  <a:avLst/>
                </a:prstGeom>
              </p:spPr>
            </p:pic>
            <p:pic>
              <p:nvPicPr>
                <p:cNvPr id="13" name="Immagine 12" descr="DSC09476.JPG">
                  <a:extLst>
                    <a:ext uri="{FF2B5EF4-FFF2-40B4-BE49-F238E27FC236}">
                      <a16:creationId xmlns:a16="http://schemas.microsoft.com/office/drawing/2014/main" xmlns="" id="{B052A74B-D8C3-7588-AA16-B17C6BEF35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/>
                <a:srcRect l="2751" t="2401" r="3538" b="5201"/>
                <a:stretch>
                  <a:fillRect/>
                </a:stretch>
              </p:blipFill>
              <p:spPr>
                <a:xfrm>
                  <a:off x="1978013" y="2352360"/>
                  <a:ext cx="2848820" cy="1828408"/>
                </a:xfrm>
                <a:prstGeom prst="rect">
                  <a:avLst/>
                </a:prstGeom>
              </p:spPr>
            </p:pic>
            <p:pic>
              <p:nvPicPr>
                <p:cNvPr id="14" name="Immagine 13" descr="DSC09482.JPG">
                  <a:extLst>
                    <a:ext uri="{FF2B5EF4-FFF2-40B4-BE49-F238E27FC236}">
                      <a16:creationId xmlns:a16="http://schemas.microsoft.com/office/drawing/2014/main" xmlns="" id="{0584832E-23EB-1319-A0D9-421C7859EB4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/>
                <a:srcRect l="7476" r="8263" b="9048"/>
                <a:stretch/>
              </p:blipFill>
              <p:spPr>
                <a:xfrm>
                  <a:off x="7020562" y="2351855"/>
                  <a:ext cx="3006438" cy="1826973"/>
                </a:xfrm>
                <a:prstGeom prst="rect">
                  <a:avLst/>
                </a:prstGeom>
              </p:spPr>
            </p:pic>
            <p:pic>
              <p:nvPicPr>
                <p:cNvPr id="15" name="Immagine 14" descr="DSC09454.JPG">
                  <a:extLst>
                    <a:ext uri="{FF2B5EF4-FFF2-40B4-BE49-F238E27FC236}">
                      <a16:creationId xmlns:a16="http://schemas.microsoft.com/office/drawing/2014/main" xmlns="" id="{3393CB0A-00FD-19D0-8CCF-C75F699A0F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 cstate="print"/>
                <a:srcRect l="16516" t="-965" r="13750"/>
                <a:stretch/>
              </p:blipFill>
              <p:spPr>
                <a:xfrm>
                  <a:off x="4900490" y="579210"/>
                  <a:ext cx="2428752" cy="1712565"/>
                </a:xfrm>
                <a:prstGeom prst="rect">
                  <a:avLst/>
                </a:prstGeom>
              </p:spPr>
            </p:pic>
            <p:pic>
              <p:nvPicPr>
                <p:cNvPr id="16" name="Immagine 15" descr="DSC09539.JPG">
                  <a:extLst>
                    <a:ext uri="{FF2B5EF4-FFF2-40B4-BE49-F238E27FC236}">
                      <a16:creationId xmlns:a16="http://schemas.microsoft.com/office/drawing/2014/main" xmlns="" id="{468E3EA2-E3AF-271D-B4E3-749F224223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/>
                <a:srcRect l="20076" r="19349" b="2941"/>
                <a:stretch>
                  <a:fillRect/>
                </a:stretch>
              </p:blipFill>
              <p:spPr>
                <a:xfrm>
                  <a:off x="4900490" y="2350811"/>
                  <a:ext cx="2047662" cy="1831505"/>
                </a:xfrm>
                <a:prstGeom prst="rect">
                  <a:avLst/>
                </a:prstGeom>
              </p:spPr>
            </p:pic>
            <p:pic>
              <p:nvPicPr>
                <p:cNvPr id="19" name="Immagine 18" descr="DSC09458.JPG">
                  <a:extLst>
                    <a:ext uri="{FF2B5EF4-FFF2-40B4-BE49-F238E27FC236}">
                      <a16:creationId xmlns:a16="http://schemas.microsoft.com/office/drawing/2014/main" xmlns="" id="{6BE8DB79-C11A-1E64-6012-4B3D486D4F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print"/>
                <a:srcRect l="4660" t="713" r="1869" b="4889"/>
                <a:stretch/>
              </p:blipFill>
              <p:spPr>
                <a:xfrm>
                  <a:off x="7402899" y="599576"/>
                  <a:ext cx="2624101" cy="1685228"/>
                </a:xfrm>
                <a:prstGeom prst="rect">
                  <a:avLst/>
                </a:prstGeom>
              </p:spPr>
            </p:pic>
          </p:grpSp>
          <p:pic>
            <p:nvPicPr>
              <p:cNvPr id="4" name="Immagine 3">
                <a:extLst>
                  <a:ext uri="{FF2B5EF4-FFF2-40B4-BE49-F238E27FC236}">
                    <a16:creationId xmlns:a16="http://schemas.microsoft.com/office/drawing/2014/main" xmlns="" id="{2C8A8759-6BCB-3FA5-88D1-EF79E44A16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433" t="9744" r="6945" b="24981"/>
              <a:stretch/>
            </p:blipFill>
            <p:spPr>
              <a:xfrm rot="16200000">
                <a:off x="8136808" y="3981625"/>
                <a:ext cx="1837191" cy="2512822"/>
              </a:xfrm>
              <a:prstGeom prst="rect">
                <a:avLst/>
              </a:prstGeom>
            </p:spPr>
          </p:pic>
        </p:grp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xmlns="" id="{12229C0B-2B52-F5D1-FBC9-13CA0D0B4673}"/>
                </a:ext>
              </a:extLst>
            </p:cNvPr>
            <p:cNvSpPr txBox="1"/>
            <p:nvPr/>
          </p:nvSpPr>
          <p:spPr>
            <a:xfrm>
              <a:off x="2147742" y="7797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a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xmlns="" id="{AA18A6FF-240A-9922-ABD9-8812811C20D1}"/>
                </a:ext>
              </a:extLst>
            </p:cNvPr>
            <p:cNvSpPr txBox="1"/>
            <p:nvPr/>
          </p:nvSpPr>
          <p:spPr>
            <a:xfrm>
              <a:off x="5095618" y="7797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b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xmlns="" id="{F1A95655-4FC3-BF71-E4B4-5EECEEFB1876}"/>
                </a:ext>
              </a:extLst>
            </p:cNvPr>
            <p:cNvSpPr txBox="1"/>
            <p:nvPr/>
          </p:nvSpPr>
          <p:spPr>
            <a:xfrm>
              <a:off x="7589442" y="-12700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xmlns="" id="{7477E39C-0B50-87FE-5F3F-0BC8E2FF2915}"/>
                </a:ext>
              </a:extLst>
            </p:cNvPr>
            <p:cNvSpPr txBox="1"/>
            <p:nvPr/>
          </p:nvSpPr>
          <p:spPr>
            <a:xfrm>
              <a:off x="2137585" y="1747384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d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xmlns="" id="{2F91A4C9-4A71-582D-817A-7A4B5FDAF026}"/>
                </a:ext>
              </a:extLst>
            </p:cNvPr>
            <p:cNvSpPr txBox="1"/>
            <p:nvPr/>
          </p:nvSpPr>
          <p:spPr>
            <a:xfrm>
              <a:off x="5056725" y="1724315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e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xmlns="" id="{BF8D6521-077A-B8E2-4CD6-8A25DD1D7EBA}"/>
                </a:ext>
              </a:extLst>
            </p:cNvPr>
            <p:cNvSpPr txBox="1"/>
            <p:nvPr/>
          </p:nvSpPr>
          <p:spPr>
            <a:xfrm>
              <a:off x="7217062" y="1806418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f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xmlns="" id="{DF6AEEBE-628A-9BBD-DC7F-8F84076189B9}"/>
                </a:ext>
              </a:extLst>
            </p:cNvPr>
            <p:cNvSpPr txBox="1"/>
            <p:nvPr/>
          </p:nvSpPr>
          <p:spPr>
            <a:xfrm>
              <a:off x="2168740" y="3639334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g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xmlns="" id="{3A4EF224-E652-035C-523E-D2884B4A5648}"/>
                </a:ext>
              </a:extLst>
            </p:cNvPr>
            <p:cNvSpPr txBox="1"/>
            <p:nvPr/>
          </p:nvSpPr>
          <p:spPr>
            <a:xfrm>
              <a:off x="5385828" y="3639334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>
                  <a:solidFill>
                    <a:schemeClr val="bg1"/>
                  </a:solidFill>
                </a:rPr>
                <a:t>h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xmlns="" id="{032EE70F-3545-19C4-D897-7249D29B1364}"/>
                </a:ext>
              </a:extLst>
            </p:cNvPr>
            <p:cNvSpPr txBox="1"/>
            <p:nvPr/>
          </p:nvSpPr>
          <p:spPr>
            <a:xfrm>
              <a:off x="7691618" y="3639334"/>
              <a:ext cx="3175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i</a:t>
              </a:r>
            </a:p>
          </p:txBody>
        </p:sp>
      </p:grpSp>
      <p:sp>
        <p:nvSpPr>
          <p:cNvPr id="6" name="CasellaDiTesto 5">
            <a:extLst>
              <a:ext uri="{FF2B5EF4-FFF2-40B4-BE49-F238E27FC236}">
                <a16:creationId xmlns:a16="http://schemas.microsoft.com/office/drawing/2014/main" xmlns="" id="{E33E4272-66B9-1592-AF21-C431E90D4DCD}"/>
              </a:ext>
            </a:extLst>
          </p:cNvPr>
          <p:cNvSpPr txBox="1"/>
          <p:nvPr/>
        </p:nvSpPr>
        <p:spPr>
          <a:xfrm>
            <a:off x="209550" y="6072883"/>
            <a:ext cx="117729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it-IT" sz="1400" b="0" i="0" u="none" strike="noStrike" baseline="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Figure S1: </a:t>
            </a:r>
            <a:r>
              <a:rPr lang="it-IT" sz="1400" b="0" i="0" u="none" strike="noStrike" baseline="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tillborn</a:t>
            </a:r>
            <a:r>
              <a:rPr lang="it-IT" sz="1400" b="0" i="0" u="none" strike="noStrike" baseline="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ambs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ffected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by SBV.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ongenital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m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lformations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include severe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rthrogryposis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of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ll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four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imbs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it-IT" sz="14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kyphosis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u="none" strike="noStrike" baseline="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and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orticollis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it-IT" sz="1400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-e),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brachygnathia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of the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ower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jaw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it-IT" sz="1400" dirty="0">
                <a:latin typeface="Palatino Linotype" panose="02040502050505030304" pitchFamily="18" charset="0"/>
                <a:cs typeface="Arial" panose="020B0604020202020204" pitchFamily="34" charset="0"/>
              </a:rPr>
              <a:t>f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</a:t>
            </a:r>
            <a:r>
              <a:rPr lang="it-IT" sz="1400" dirty="0">
                <a:solidFill>
                  <a:srgbClr val="1B1B1B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solidFill>
                  <a:srgbClr val="1B1B1B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cerebellar</a:t>
            </a:r>
            <a:r>
              <a:rPr lang="it-IT" sz="1400" dirty="0">
                <a:solidFill>
                  <a:srgbClr val="1B1B1B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solidFill>
                  <a:srgbClr val="1B1B1B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hypoplasia</a:t>
            </a:r>
            <a:r>
              <a:rPr lang="it-IT" sz="1400" dirty="0">
                <a:solidFill>
                  <a:srgbClr val="1B1B1B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 (black </a:t>
            </a:r>
            <a:r>
              <a:rPr lang="it-IT" sz="1400" dirty="0" err="1">
                <a:solidFill>
                  <a:srgbClr val="1B1B1B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arrow</a:t>
            </a:r>
            <a:r>
              <a:rPr lang="it-IT" sz="1400" dirty="0">
                <a:solidFill>
                  <a:srgbClr val="1B1B1B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) (g), 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u="none" strike="noStrike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hydrocephalus</a:t>
            </a:r>
            <a:r>
              <a:rPr lang="it-IT" sz="1400" b="0" i="0" u="none" strike="noStrike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(h) and </a:t>
            </a:r>
            <a:r>
              <a:rPr lang="it-IT" sz="1400" b="0" i="0" dirty="0" err="1">
                <a:solidFill>
                  <a:srgbClr val="1B1B1B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unilateral</a:t>
            </a:r>
            <a:r>
              <a:rPr lang="it-IT" sz="1400" b="0" i="0" dirty="0">
                <a:solidFill>
                  <a:srgbClr val="1B1B1B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400" b="0" i="0" dirty="0" err="1">
                <a:solidFill>
                  <a:srgbClr val="1B1B1B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hydronephrosis</a:t>
            </a:r>
            <a:r>
              <a:rPr lang="it-IT" sz="1400" b="0" i="0" dirty="0">
                <a:solidFill>
                  <a:srgbClr val="1B1B1B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(i).</a:t>
            </a:r>
            <a:endParaRPr lang="it-IT" sz="1400" b="0" i="0" u="none" strike="noStrike" baseline="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2" name="Freccia a destra 1">
            <a:extLst>
              <a:ext uri="{FF2B5EF4-FFF2-40B4-BE49-F238E27FC236}">
                <a16:creationId xmlns:a16="http://schemas.microsoft.com/office/drawing/2014/main" xmlns="" id="{1E7675FE-D106-CA10-0CED-A6CFD20C801B}"/>
              </a:ext>
            </a:extLst>
          </p:cNvPr>
          <p:cNvSpPr/>
          <p:nvPr/>
        </p:nvSpPr>
        <p:spPr>
          <a:xfrm rot="20279535">
            <a:off x="4360343" y="5483558"/>
            <a:ext cx="320211" cy="14351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16657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61</Words>
  <Application>Microsoft Office PowerPoint</Application>
  <PresentationFormat>Personalizzato</PresentationFormat>
  <Paragraphs>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avide Pintus</dc:creator>
  <cp:lastModifiedBy>Dei Giudici Silvia</cp:lastModifiedBy>
  <cp:revision>6</cp:revision>
  <dcterms:created xsi:type="dcterms:W3CDTF">2024-11-05T13:24:15Z</dcterms:created>
  <dcterms:modified xsi:type="dcterms:W3CDTF">2024-11-14T15:48:35Z</dcterms:modified>
</cp:coreProperties>
</file>